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300" r:id="rId2"/>
  </p:sldIdLst>
  <p:sldSz cx="7559675" cy="10439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7EFDE27-64D2-9A47-7EBA-F4D877437D86}" name="Crevel, Reinout van" initials="" userId="S::Reinout.vanCrevel@radboudumc.nl::c8a85eab-04e2-4374-80ac-ff56393b1662" providerId="AD"/>
  <p188:author id="{0A69D33C-A3AE-B2FD-DAE3-489C6085493B}" name="Setiabudiawan, Todia" initials="TS" userId="S::Todia.Setiabudiawan@radboudumc.nl::b66113ee-6b80-4b22-902e-4e4411cc18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335"/>
    <p:restoredTop sz="94720"/>
  </p:normalViewPr>
  <p:slideViewPr>
    <p:cSldViewPr snapToGrid="0">
      <p:cViewPr varScale="1">
        <p:scale>
          <a:sx n="67" d="100"/>
          <a:sy n="67" d="100"/>
        </p:scale>
        <p:origin x="24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D36B6E-0244-7342-9A93-7D998A0B8A7C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143000"/>
            <a:ext cx="2235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6B7A9C-8B5B-7A4D-836E-05FD47B0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4364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011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77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884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552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116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748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129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565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88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212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03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42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CE08C158-A1AA-10D6-2CCF-CFBB68320134}"/>
              </a:ext>
            </a:extLst>
          </p:cNvPr>
          <p:cNvSpPr txBox="1"/>
          <p:nvPr/>
        </p:nvSpPr>
        <p:spPr>
          <a:xfrm>
            <a:off x="108286" y="4082892"/>
            <a:ext cx="729374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NZ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Gene Ontology enrichment maps of host-response processes uniquely suppressed in L2-B-infected lungs relative to L4.</a:t>
            </a:r>
            <a:br>
              <a:rPr lang="en-NZ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Picture 29" descr="A close-up of a network&#10;&#10;Description automatically generated">
            <a:extLst>
              <a:ext uri="{FF2B5EF4-FFF2-40B4-BE49-F238E27FC236}">
                <a16:creationId xmlns:a16="http://schemas.microsoft.com/office/drawing/2014/main" id="{E9D16587-DB2A-4CD9-B90A-7C05A4B6B83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44248"/>
            <a:ext cx="3840480" cy="3899684"/>
          </a:xfrm>
          <a:prstGeom prst="rect">
            <a:avLst/>
          </a:prstGeom>
        </p:spPr>
      </p:pic>
      <p:pic>
        <p:nvPicPr>
          <p:cNvPr id="32" name="Picture 31" descr="A close-up of a chart&#10;&#10;Description automatically generated">
            <a:extLst>
              <a:ext uri="{FF2B5EF4-FFF2-40B4-BE49-F238E27FC236}">
                <a16:creationId xmlns:a16="http://schemas.microsoft.com/office/drawing/2014/main" id="{3F9AB845-91CC-DDEB-03AE-EBA9EC9BCDC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96265" y="44246"/>
            <a:ext cx="3709134" cy="38996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9434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951</TotalTime>
  <Words>21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omi Daniels</dc:creator>
  <cp:lastModifiedBy>Naomi Daniels</cp:lastModifiedBy>
  <cp:revision>5</cp:revision>
  <dcterms:created xsi:type="dcterms:W3CDTF">2025-04-08T03:28:33Z</dcterms:created>
  <dcterms:modified xsi:type="dcterms:W3CDTF">2026-03-30T03:31:11Z</dcterms:modified>
</cp:coreProperties>
</file>